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245225" cy="457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366" y="1182"/>
      </p:cViewPr>
      <p:guideLst>
        <p:guide orient="horz" pos="1440"/>
        <p:guide pos="19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8394" y="1420284"/>
            <a:ext cx="5308441" cy="9800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6784" y="2590800"/>
            <a:ext cx="4371658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2256" y="244475"/>
            <a:ext cx="959553" cy="52006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597" y="244475"/>
            <a:ext cx="2774571" cy="52006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332" y="2937934"/>
            <a:ext cx="5308441" cy="90805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332" y="1937810"/>
            <a:ext cx="5308441" cy="100012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3596" y="1422401"/>
            <a:ext cx="1867062" cy="40227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4745" y="1422401"/>
            <a:ext cx="1867062" cy="40227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2263" y="183092"/>
            <a:ext cx="5620703" cy="762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261" y="1023408"/>
            <a:ext cx="2759392" cy="4265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2261" y="1449917"/>
            <a:ext cx="2759392" cy="26341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2489" y="1023408"/>
            <a:ext cx="2760476" cy="4265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2489" y="1449917"/>
            <a:ext cx="2760476" cy="26341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2262" y="182034"/>
            <a:ext cx="2054636" cy="7747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1710" y="182035"/>
            <a:ext cx="3491254" cy="390207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2262" y="956734"/>
            <a:ext cx="2054636" cy="31273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4109" y="3200401"/>
            <a:ext cx="3747135" cy="37782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4109" y="408516"/>
            <a:ext cx="3747135" cy="27432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4109" y="3578226"/>
            <a:ext cx="3747135" cy="53657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2263" y="183092"/>
            <a:ext cx="5620703" cy="762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263" y="1066801"/>
            <a:ext cx="5620703" cy="30173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2262" y="4237568"/>
            <a:ext cx="1457219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59D8D-F24B-4EC6-9FE6-D713E02942A2}" type="datetimeFigureOut">
              <a:rPr lang="en-US" smtClean="0"/>
              <a:pPr/>
              <a:t>4/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33787" y="4237568"/>
            <a:ext cx="1977655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75746" y="4237568"/>
            <a:ext cx="1457219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620CF-4D69-4908-A496-C46FC6C722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263151" y="228600"/>
            <a:ext cx="5918567" cy="1797278"/>
            <a:chOff x="685800" y="0"/>
            <a:chExt cx="4734854" cy="1437822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2133600" y="381000"/>
              <a:ext cx="3124200" cy="0"/>
            </a:xfrm>
            <a:prstGeom prst="line">
              <a:avLst/>
            </a:prstGeom>
            <a:ln w="190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685800" y="373857"/>
              <a:ext cx="137160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1676400" y="1107804"/>
              <a:ext cx="2848472" cy="1723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42           124                 183</a:t>
              </a:r>
              <a:r>
                <a:rPr lang="en-US" sz="800" dirty="0" smtClean="0">
                  <a:solidFill>
                    <a:schemeClr val="accent2"/>
                  </a:solidFill>
                  <a:latin typeface="Arial" pitchFamily="34" charset="0"/>
                  <a:cs typeface="Arial" pitchFamily="34" charset="0"/>
                </a:rPr>
                <a:t>442   460                                          746 802</a:t>
              </a:r>
              <a:endParaRPr lang="en-US" sz="800" dirty="0">
                <a:solidFill>
                  <a:schemeClr val="accent2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85800" y="437245"/>
              <a:ext cx="1417311" cy="1723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42           124            339         420</a:t>
              </a:r>
              <a:endParaRPr lang="en-US" sz="8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133600" y="437245"/>
              <a:ext cx="3287054" cy="1723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accent2"/>
                  </a:solidFill>
                  <a:latin typeface="Arial" pitchFamily="34" charset="0"/>
                  <a:cs typeface="Arial" pitchFamily="34" charset="0"/>
                </a:rPr>
                <a:t>38        104  147      239  249      349                   460                                          746</a:t>
              </a:r>
              <a:endParaRPr lang="en-US" sz="800" dirty="0">
                <a:solidFill>
                  <a:schemeClr val="accent2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762000" y="297657"/>
              <a:ext cx="457200" cy="1524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N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209800" y="304800"/>
              <a:ext cx="3810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G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962400" y="304800"/>
              <a:ext cx="12192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K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85800" y="0"/>
              <a:ext cx="881831" cy="221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EL structure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209800" y="0"/>
              <a:ext cx="1064651" cy="221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FGFR4 structure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600200" y="1216223"/>
              <a:ext cx="1331390" cy="221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EL-FGFR4 structure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3" name="Group 78"/>
            <p:cNvGrpSpPr/>
            <p:nvPr/>
          </p:nvGrpSpPr>
          <p:grpSpPr>
            <a:xfrm>
              <a:off x="685800" y="533400"/>
              <a:ext cx="609600" cy="76200"/>
              <a:chOff x="914400" y="2133600"/>
              <a:chExt cx="838200" cy="76200"/>
            </a:xfrm>
          </p:grpSpPr>
          <p:cxnSp>
            <p:nvCxnSpPr>
              <p:cNvPr id="82" name="Straight Connector 81"/>
              <p:cNvCxnSpPr/>
              <p:nvPr/>
            </p:nvCxnSpPr>
            <p:spPr>
              <a:xfrm>
                <a:off x="914400" y="2133600"/>
                <a:ext cx="0" cy="762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1752600" y="2133600"/>
                <a:ext cx="0" cy="762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914400" y="2209800"/>
                <a:ext cx="838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64" name="Straight Connector 63"/>
            <p:cNvCxnSpPr/>
            <p:nvPr/>
          </p:nvCxnSpPr>
          <p:spPr>
            <a:xfrm>
              <a:off x="990600" y="609600"/>
              <a:ext cx="0" cy="76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990600" y="685800"/>
              <a:ext cx="9906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>
              <a:off x="1981200" y="685800"/>
              <a:ext cx="0" cy="2286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7" name="Group 79"/>
            <p:cNvGrpSpPr/>
            <p:nvPr/>
          </p:nvGrpSpPr>
          <p:grpSpPr>
            <a:xfrm>
              <a:off x="3886200" y="533400"/>
              <a:ext cx="1371600" cy="76200"/>
              <a:chOff x="914400" y="2133600"/>
              <a:chExt cx="990600" cy="76200"/>
            </a:xfrm>
          </p:grpSpPr>
          <p:cxnSp>
            <p:nvCxnSpPr>
              <p:cNvPr id="79" name="Straight Connector 78"/>
              <p:cNvCxnSpPr/>
              <p:nvPr/>
            </p:nvCxnSpPr>
            <p:spPr>
              <a:xfrm>
                <a:off x="914400" y="2133600"/>
                <a:ext cx="0" cy="762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1905000" y="2133600"/>
                <a:ext cx="0" cy="762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914400" y="2209800"/>
                <a:ext cx="990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68" name="Straight Connector 67"/>
            <p:cNvCxnSpPr/>
            <p:nvPr/>
          </p:nvCxnSpPr>
          <p:spPr>
            <a:xfrm>
              <a:off x="4572000" y="609600"/>
              <a:ext cx="0" cy="76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 flipH="1">
              <a:off x="3581400" y="685800"/>
              <a:ext cx="9906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Arrow Connector 69"/>
            <p:cNvCxnSpPr/>
            <p:nvPr/>
          </p:nvCxnSpPr>
          <p:spPr>
            <a:xfrm>
              <a:off x="3581400" y="685800"/>
              <a:ext cx="0" cy="2286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Rectangle 70"/>
            <p:cNvSpPr/>
            <p:nvPr/>
          </p:nvSpPr>
          <p:spPr>
            <a:xfrm>
              <a:off x="1524000" y="297657"/>
              <a:ext cx="457200" cy="1524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ET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2667000" y="304800"/>
              <a:ext cx="3810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G</a:t>
              </a: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3124200" y="304800"/>
              <a:ext cx="3810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G</a:t>
              </a: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581400" y="304800"/>
              <a:ext cx="762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200" dirty="0" smtClean="0"/>
            </a:p>
          </p:txBody>
        </p:sp>
        <p:cxnSp>
          <p:nvCxnSpPr>
            <p:cNvPr id="75" name="Straight Connector 74"/>
            <p:cNvCxnSpPr/>
            <p:nvPr/>
          </p:nvCxnSpPr>
          <p:spPr>
            <a:xfrm>
              <a:off x="1600200" y="1066800"/>
              <a:ext cx="114300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Rectangle 75"/>
            <p:cNvSpPr/>
            <p:nvPr/>
          </p:nvSpPr>
          <p:spPr>
            <a:xfrm>
              <a:off x="1752600" y="990600"/>
              <a:ext cx="457200" cy="1524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N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Straight Connector 76"/>
            <p:cNvCxnSpPr/>
            <p:nvPr/>
          </p:nvCxnSpPr>
          <p:spPr>
            <a:xfrm>
              <a:off x="2743200" y="1066800"/>
              <a:ext cx="1600200" cy="0"/>
            </a:xfrm>
            <a:prstGeom prst="line">
              <a:avLst/>
            </a:prstGeom>
            <a:ln w="190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8" name="Rectangle 77"/>
            <p:cNvSpPr/>
            <p:nvPr/>
          </p:nvSpPr>
          <p:spPr>
            <a:xfrm>
              <a:off x="2971800" y="990600"/>
              <a:ext cx="1219200" cy="152400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K</a:t>
              </a:r>
            </a:p>
          </p:txBody>
        </p:sp>
      </p:grpSp>
      <p:grpSp>
        <p:nvGrpSpPr>
          <p:cNvPr id="85" name="Group 84"/>
          <p:cNvGrpSpPr>
            <a:grpSpLocks noChangeAspect="1"/>
          </p:cNvGrpSpPr>
          <p:nvPr/>
        </p:nvGrpSpPr>
        <p:grpSpPr>
          <a:xfrm>
            <a:off x="124659" y="2375681"/>
            <a:ext cx="2637970" cy="1739119"/>
            <a:chOff x="2683338" y="2057400"/>
            <a:chExt cx="2009658" cy="1324895"/>
          </a:xfrm>
        </p:grpSpPr>
        <p:sp>
          <p:nvSpPr>
            <p:cNvPr id="86" name="TextBox 85"/>
            <p:cNvSpPr txBox="1"/>
            <p:nvPr/>
          </p:nvSpPr>
          <p:spPr>
            <a:xfrm>
              <a:off x="2975344" y="2323327"/>
              <a:ext cx="368705" cy="211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pTyr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736654" y="2706527"/>
              <a:ext cx="609600" cy="2110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otal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270054" y="2057400"/>
              <a:ext cx="1422942" cy="211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Vector Ctrl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TEL-FGFR4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9" name="Picture 5"/>
            <p:cNvPicPr>
              <a:picLocks noChangeAspect="1" noChangeArrowheads="1"/>
            </p:cNvPicPr>
            <p:nvPr/>
          </p:nvPicPr>
          <p:blipFill>
            <a:blip r:embed="rId2" cstate="print">
              <a:lum bright="-10000"/>
            </a:blip>
            <a:srcRect r="2518"/>
            <a:stretch>
              <a:fillRect/>
            </a:stretch>
          </p:blipFill>
          <p:spPr bwMode="auto">
            <a:xfrm>
              <a:off x="3346255" y="2286000"/>
              <a:ext cx="1225746" cy="322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0" name="Picture 7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346253" y="2667000"/>
              <a:ext cx="1225747" cy="322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1" name="Picture 8"/>
            <p:cNvPicPr>
              <a:picLocks noChangeAspect="1" noChangeArrowheads="1"/>
            </p:cNvPicPr>
            <p:nvPr/>
          </p:nvPicPr>
          <p:blipFill>
            <a:blip r:embed="rId4" cstate="print"/>
            <a:srcRect l="5263"/>
            <a:stretch>
              <a:fillRect/>
            </a:stretch>
          </p:blipFill>
          <p:spPr bwMode="auto">
            <a:xfrm>
              <a:off x="3346254" y="3048000"/>
              <a:ext cx="1225746" cy="3342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2" name="TextBox 91"/>
            <p:cNvSpPr txBox="1"/>
            <p:nvPr/>
          </p:nvSpPr>
          <p:spPr>
            <a:xfrm>
              <a:off x="2852644" y="3087527"/>
              <a:ext cx="493608" cy="211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1200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683338" y="2145474"/>
              <a:ext cx="669462" cy="211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u="sng" dirty="0" smtClean="0">
                  <a:latin typeface="Arial" pitchFamily="34" charset="0"/>
                  <a:cs typeface="Arial" pitchFamily="34" charset="0"/>
                </a:rPr>
                <a:t>IP:FGFR4</a:t>
              </a:r>
              <a:endParaRPr lang="en-US" sz="1200" u="sng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94" name="Picture 2" descr="T:\Sam Li\Adam's Paper\Manuscript\FINAL\Data 1.tif"/>
          <p:cNvPicPr>
            <a:picLocks noChangeAspect="1" noChangeArrowheads="1"/>
          </p:cNvPicPr>
          <p:nvPr/>
        </p:nvPicPr>
        <p:blipFill>
          <a:blip r:embed="rId5" cstate="print"/>
          <a:srcRect r="4811"/>
          <a:stretch>
            <a:fillRect/>
          </a:stretch>
        </p:blipFill>
        <p:spPr bwMode="auto">
          <a:xfrm>
            <a:off x="3198812" y="2210778"/>
            <a:ext cx="3046413" cy="2285022"/>
          </a:xfrm>
          <a:prstGeom prst="rect">
            <a:avLst/>
          </a:prstGeom>
          <a:noFill/>
        </p:spPr>
      </p:pic>
      <p:sp>
        <p:nvSpPr>
          <p:cNvPr id="95" name="TextBox 94"/>
          <p:cNvSpPr txBox="1"/>
          <p:nvPr/>
        </p:nvSpPr>
        <p:spPr>
          <a:xfrm>
            <a:off x="0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0" y="2133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903538" y="2133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3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s5</dc:creator>
  <cp:lastModifiedBy>lis5</cp:lastModifiedBy>
  <cp:revision>3</cp:revision>
  <dcterms:created xsi:type="dcterms:W3CDTF">2013-03-26T16:08:57Z</dcterms:created>
  <dcterms:modified xsi:type="dcterms:W3CDTF">2013-04-01T18:46:33Z</dcterms:modified>
</cp:coreProperties>
</file>